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media/image4.png" ContentType="image/png"/>
  <Override PartName="/ppt/media/image5.jpeg" ContentType="image/jpeg"/>
  <Override PartName="/ppt/media/image6.jpeg" ContentType="image/jpeg"/>
  <Override PartName="/ppt/media/image8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4A2B92-3722-4D0D-8124-3F687F332A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48FC1-3A00-42A3-8025-D26F046054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22A388-994A-4F4E-A686-BB6D1DEAC4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3F435C-0019-49C3-A81C-31E15ECB84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3DB4E1-E9AD-43E1-8806-37B368664B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581125-0E49-45AA-BDB4-C9C49CD29F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FB235C-06AA-4689-AB3E-5EE69B64E9A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9005E-4530-4014-9FA0-11A51A5CCC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6EA413-257C-4617-B8BC-A022B54128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412B24-6ACF-4011-99C5-EB18A55822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BB4817-4CDC-4396-B5CB-FBC6051BA7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20D877-99E2-415B-B8C8-077523ADB6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8354812-7215-458B-81B7-3EE8BA7B65E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0" r="0" b="11173"/>
          <a:stretch/>
        </p:blipFill>
        <p:spPr>
          <a:xfrm>
            <a:off x="4932360" y="3860640"/>
            <a:ext cx="3743280" cy="282600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rcRect l="0" t="0" r="0" b="9327"/>
          <a:stretch/>
        </p:blipFill>
        <p:spPr>
          <a:xfrm>
            <a:off x="4896000" y="692280"/>
            <a:ext cx="3776400" cy="282564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3134880" y="115920"/>
            <a:ext cx="323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BE" sz="1800" spc="-1" strike="noStrike">
                <a:solidFill>
                  <a:srgbClr val="000000"/>
                </a:solidFill>
                <a:latin typeface="Arial"/>
              </a:rPr>
              <a:t>CASE 1 : NON-RESPOND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085440" y="1197000"/>
            <a:ext cx="218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800" spc="-1" strike="noStrike">
                <a:solidFill>
                  <a:srgbClr val="ffffff"/>
                </a:solidFill>
                <a:latin typeface="Arial"/>
              </a:rPr>
              <a:t>Aortic TVI : 7.97 c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6156720" y="4365720"/>
            <a:ext cx="218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800" spc="-1" strike="noStrike">
                <a:solidFill>
                  <a:srgbClr val="ffffff"/>
                </a:solidFill>
                <a:latin typeface="Arial"/>
              </a:rPr>
              <a:t>Aortic TVI : 8.04 c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395280" y="692280"/>
            <a:ext cx="4108320" cy="279072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4"/>
          <a:stretch/>
        </p:blipFill>
        <p:spPr>
          <a:xfrm>
            <a:off x="395280" y="3881520"/>
            <a:ext cx="4105440" cy="27874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afterEffect" fill="hold" presetClass="mediacall" presetID="1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00" fill="hold"/>
                                        <p:tgtEl>
                                          <p:spTgt spid="4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900"/>
                            </p:stCondLst>
                            <p:childTnLst>
                              <p:par>
                                <p:cTn id="8" nodeType="afterEffect" fill="hold" presetClass="mediacall" presetID="1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9" dur="980" fill="hold"/>
                                        <p:tgtEl>
                                          <p:spTgt spid="4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  <p:seq>
              <p:cTn id="10" restart="whenNotActive" nodeType="interactiveSeq" fill="hold">
                <p:stCondLst>
                  <p:cond evt="onClick">
                    <p:tgtEl>
                      <p:spTgt spid="46"/>
                    </p:tgtEl>
                  </p:cond>
                </p:stCondLst>
                <p:childTnLst>
                  <p:par>
                    <p:cTn id="11" fill="hold">
                      <p:stCondLst>
                        <p:cond evt="onClick">
                          <p:tgtEl>
                            <p:spTgt spid="46"/>
                          </p:tgtEl>
                        </p:cond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nodeType="clickEffect" fill="hold" presetClass="mediacall" presetID="2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4" dur="1" fill="hold"/>
                                        <p:tgtEl>
                                          <p:spTgt spid="4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  <p:seq>
              <p:cTn id="15" restart="whenNotActive" nodeType="interactiveSeq" fill="hold">
                <p:stCondLst>
                  <p:cond evt="onClick">
                    <p:tgtEl>
                      <p:spTgt spid="47"/>
                    </p:tgtEl>
                  </p:cond>
                </p:stCondLst>
                <p:childTnLst>
                  <p:par>
                    <p:cTn id="16" fill="hold">
                      <p:stCondLst>
                        <p:cond evt="onClick">
                          <p:tgtEl>
                            <p:spTgt spid="47"/>
                          </p:tgtEl>
                        </p:cond>
                      </p:stCondLst>
                      <p:childTnLst>
                        <p:par>
                          <p:cTn id="17" fill="hold">
                            <p:stCondLst>
                              <p:cond delay="0"/>
                            </p:stCondLst>
                            <p:childTnLst>
                              <p:par>
                                <p:cTn id="18" nodeType="clickEffect" fill="hold" presetClass="mediacall" presetID="2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9" dur="1" fill="hold"/>
                                        <p:tgtEl>
                                          <p:spTgt spid="4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4932360" y="765000"/>
            <a:ext cx="3600360" cy="268632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2"/>
          <a:stretch/>
        </p:blipFill>
        <p:spPr>
          <a:xfrm>
            <a:off x="4932360" y="4005360"/>
            <a:ext cx="3600360" cy="262404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6012720" y="4437000"/>
            <a:ext cx="231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800" spc="-1" strike="noStrike">
                <a:solidFill>
                  <a:srgbClr val="ffffff"/>
                </a:solidFill>
                <a:latin typeface="Arial"/>
              </a:rPr>
              <a:t>Aortic TVI : 20.43 c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6012720" y="1052640"/>
            <a:ext cx="2315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BE" sz="1800" spc="-1" strike="noStrike">
                <a:solidFill>
                  <a:srgbClr val="ffffff"/>
                </a:solidFill>
                <a:latin typeface="Arial"/>
              </a:rPr>
              <a:t>Aortic TVI : 10.36 c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134520" y="115920"/>
            <a:ext cx="2655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BE" sz="1800" spc="-1" strike="noStrike">
                <a:solidFill>
                  <a:srgbClr val="000000"/>
                </a:solidFill>
                <a:latin typeface="Arial"/>
              </a:rPr>
              <a:t>CASE 2 : RESPOND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" descr=""/>
          <p:cNvPicPr/>
          <p:nvPr/>
        </p:nvPicPr>
        <p:blipFill>
          <a:blip r:embed="rId3"/>
          <a:stretch/>
        </p:blipFill>
        <p:spPr>
          <a:xfrm>
            <a:off x="324000" y="765000"/>
            <a:ext cx="3887640" cy="2824200"/>
          </a:xfrm>
          <a:prstGeom prst="rect">
            <a:avLst/>
          </a:prstGeom>
          <a:ln w="0">
            <a:noFill/>
          </a:ln>
        </p:spPr>
      </p:pic>
      <p:pic>
        <p:nvPicPr>
          <p:cNvPr id="54" name="" descr=""/>
          <p:cNvPicPr/>
          <p:nvPr/>
        </p:nvPicPr>
        <p:blipFill>
          <a:blip r:embed="rId4"/>
          <a:stretch/>
        </p:blipFill>
        <p:spPr>
          <a:xfrm>
            <a:off x="324000" y="3933720"/>
            <a:ext cx="3960720" cy="2691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20" dur="indefinite" restart="never" nodeType="tmRoot">
          <p:childTnLst>
            <p:seq>
              <p:cTn id="21" dur="indefinite" nodeType="mainSeq">
                <p:childTnLst>
                  <p:par>
                    <p:cTn id="22" fill="hold">
                      <p:stCondLst>
                        <p:cond delay="0"/>
                      </p:stCondLst>
                      <p:childTnLst>
                        <p:par>
                          <p:cTn id="23" fill="hold">
                            <p:stCondLst>
                              <p:cond delay="0"/>
                            </p:stCondLst>
                            <p:childTnLst>
                              <p:par>
                                <p:cTn id="24" nodeType="afterEffect" fill="hold" presetClass="mediacall" presetID="1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5" dur="960" fill="hold"/>
                                        <p:tgtEl>
                                          <p:spTgt spid="5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" fill="hold">
                            <p:stCondLst>
                              <p:cond delay="960"/>
                            </p:stCondLst>
                            <p:childTnLst>
                              <p:par>
                                <p:cTn id="27" nodeType="afterEffect" fill="hold" presetClass="mediacall" presetID="1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8" dur="960" fill="hold"/>
                                        <p:tgtEl>
                                          <p:spTgt spid="5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  <p:seq>
              <p:cTn id="29" restart="whenNotActive" nodeType="interactiveSeq" fill="hold">
                <p:stCondLst>
                  <p:cond evt="onClick">
                    <p:tgtEl>
                      <p:spTgt spid="53"/>
                    </p:tgtEl>
                  </p:cond>
                </p:stCondLst>
                <p:childTnLst>
                  <p:par>
                    <p:cTn id="30" fill="hold">
                      <p:stCondLst>
                        <p:cond evt="onClick">
                          <p:tgtEl>
                            <p:spTgt spid="53"/>
                          </p:tgtEl>
                        </p:cond>
                      </p:stCondLst>
                      <p:childTnLst>
                        <p:par>
                          <p:cTn id="31" fill="hold">
                            <p:stCondLst>
                              <p:cond delay="0"/>
                            </p:stCondLst>
                            <p:childTnLst>
                              <p:par>
                                <p:cTn id="32" nodeType="clickEffect" fill="hold" presetClass="mediacall" presetID="2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3" dur="1" fill="hold"/>
                                        <p:tgtEl>
                                          <p:spTgt spid="5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  <p:seq>
              <p:cTn id="34" restart="whenNotActive" nodeType="interactiveSeq" fill="hold">
                <p:stCondLst>
                  <p:cond evt="onClick">
                    <p:tgtEl>
                      <p:spTgt spid="54"/>
                    </p:tgtEl>
                  </p:cond>
                </p:stCondLst>
                <p:childTnLst>
                  <p:par>
                    <p:cTn id="35" fill="hold">
                      <p:stCondLst>
                        <p:cond evt="onClick">
                          <p:tgtEl>
                            <p:spTgt spid="54"/>
                          </p:tgtEl>
                        </p:cond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nodeType="clickEffect" fill="hold" presetClass="mediacall" presetID="2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8" dur="1" fill="hold"/>
                                        <p:tgtEl>
                                          <p:spTgt spid="5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27T13:02:15Z</dcterms:created>
  <dc:creator>user</dc:creator>
  <dc:description/>
  <dc:language>en-US</dc:language>
  <cp:lastModifiedBy>user</cp:lastModifiedBy>
  <dcterms:modified xsi:type="dcterms:W3CDTF">2008-12-18T15:54:44Z</dcterms:modified>
  <cp:revision>8</cp:revision>
  <dc:subject/>
  <dc:title>Diapositive 1</dc:title>
</cp:coreProperties>
</file>